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밝은 스타일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972" autoAdjust="0"/>
    <p:restoredTop sz="94660"/>
  </p:normalViewPr>
  <p:slideViewPr>
    <p:cSldViewPr snapToGrid="0">
      <p:cViewPr varScale="1">
        <p:scale>
          <a:sx n="93" d="100"/>
          <a:sy n="93" d="100"/>
        </p:scale>
        <p:origin x="78" y="4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B00A6-CA39-4777-8C62-36AA74B33647}" type="datetimeFigureOut">
              <a:rPr lang="ko-KR" altLang="en-US" smtClean="0"/>
              <a:t>2017-10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A159BD-1F51-4C05-8EFE-E1569537ABC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659447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B00A6-CA39-4777-8C62-36AA74B33647}" type="datetimeFigureOut">
              <a:rPr lang="ko-KR" altLang="en-US" smtClean="0"/>
              <a:t>2017-10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A159BD-1F51-4C05-8EFE-E1569537ABC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475076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B00A6-CA39-4777-8C62-36AA74B33647}" type="datetimeFigureOut">
              <a:rPr lang="ko-KR" altLang="en-US" smtClean="0"/>
              <a:t>2017-10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A159BD-1F51-4C05-8EFE-E1569537ABC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1360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B00A6-CA39-4777-8C62-36AA74B33647}" type="datetimeFigureOut">
              <a:rPr lang="ko-KR" altLang="en-US" smtClean="0"/>
              <a:t>2017-10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A159BD-1F51-4C05-8EFE-E1569537ABC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064177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B00A6-CA39-4777-8C62-36AA74B33647}" type="datetimeFigureOut">
              <a:rPr lang="ko-KR" altLang="en-US" smtClean="0"/>
              <a:t>2017-10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A159BD-1F51-4C05-8EFE-E1569537ABC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323900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B00A6-CA39-4777-8C62-36AA74B33647}" type="datetimeFigureOut">
              <a:rPr lang="ko-KR" altLang="en-US" smtClean="0"/>
              <a:t>2017-10-1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A159BD-1F51-4C05-8EFE-E1569537ABC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903812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B00A6-CA39-4777-8C62-36AA74B33647}" type="datetimeFigureOut">
              <a:rPr lang="ko-KR" altLang="en-US" smtClean="0"/>
              <a:t>2017-10-10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A159BD-1F51-4C05-8EFE-E1569537ABC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788182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B00A6-CA39-4777-8C62-36AA74B33647}" type="datetimeFigureOut">
              <a:rPr lang="ko-KR" altLang="en-US" smtClean="0"/>
              <a:t>2017-10-10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A159BD-1F51-4C05-8EFE-E1569537ABC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00924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B00A6-CA39-4777-8C62-36AA74B33647}" type="datetimeFigureOut">
              <a:rPr lang="ko-KR" altLang="en-US" smtClean="0"/>
              <a:t>2017-10-10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A159BD-1F51-4C05-8EFE-E1569537ABC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875606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B00A6-CA39-4777-8C62-36AA74B33647}" type="datetimeFigureOut">
              <a:rPr lang="ko-KR" altLang="en-US" smtClean="0"/>
              <a:t>2017-10-1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A159BD-1F51-4C05-8EFE-E1569537ABC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430604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B00A6-CA39-4777-8C62-36AA74B33647}" type="datetimeFigureOut">
              <a:rPr lang="ko-KR" altLang="en-US" smtClean="0"/>
              <a:t>2017-10-1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A159BD-1F51-4C05-8EFE-E1569537ABC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499607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BB00A6-CA39-4777-8C62-36AA74B33647}" type="datetimeFigureOut">
              <a:rPr lang="ko-KR" altLang="en-US" smtClean="0"/>
              <a:t>2017-10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A159BD-1F51-4C05-8EFE-E1569537ABC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807475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직사각형 4"/>
          <p:cNvSpPr/>
          <p:nvPr/>
        </p:nvSpPr>
        <p:spPr>
          <a:xfrm>
            <a:off x="315072" y="91350"/>
            <a:ext cx="729807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i="0" u="none" strike="noStrike" dirty="0" smtClean="0">
                <a:solidFill>
                  <a:srgbClr val="000000"/>
                </a:solidFill>
                <a:effectLst/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upplementary Tables S1. List of RT-PCR Primers sequences.</a:t>
            </a:r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graphicFrame>
        <p:nvGraphicFramePr>
          <p:cNvPr id="6" name="표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7591827"/>
              </p:ext>
            </p:extLst>
          </p:nvPr>
        </p:nvGraphicFramePr>
        <p:xfrm>
          <a:off x="315072" y="470956"/>
          <a:ext cx="8127999" cy="625348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616469"/>
                <a:gridCol w="1767155"/>
                <a:gridCol w="4744375"/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Gene</a:t>
                      </a:r>
                      <a:endParaRPr lang="ko-KR" altLang="en-US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Sequence</a:t>
                      </a:r>
                      <a:endParaRPr lang="ko-KR" altLang="en-US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/>
                </a:tc>
              </a:tr>
              <a:tr h="370840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Actin</a:t>
                      </a:r>
                      <a:endParaRPr lang="ko-KR" altLang="en-US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Forward</a:t>
                      </a:r>
                      <a:endParaRPr lang="ko-KR" altLang="en-US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TGGAATCCTGTGGCATCCATGAAAC</a:t>
                      </a:r>
                    </a:p>
                  </a:txBody>
                  <a:tcPr marL="9525" marR="9525" marT="9525" marB="0" anchor="ctr"/>
                </a:tc>
              </a:tr>
              <a:tr h="370840">
                <a:tc v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Reverse</a:t>
                      </a:r>
                      <a:endParaRPr lang="ko-KR" altLang="en-US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TAAAACGCAGCTCAGTAACAGTCCG</a:t>
                      </a:r>
                    </a:p>
                  </a:txBody>
                  <a:tcPr marL="9525" marR="9525" marT="9525" marB="0" anchor="ctr"/>
                </a:tc>
              </a:tr>
              <a:tr h="370840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Ahnak</a:t>
                      </a:r>
                      <a:endParaRPr lang="ko-KR" altLang="en-US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Forward</a:t>
                      </a:r>
                      <a:endParaRPr lang="ko-KR" altLang="en-US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AAGGAGCCTTTGATGGGTCT</a:t>
                      </a:r>
                    </a:p>
                  </a:txBody>
                  <a:tcPr marL="9525" marR="9525" marT="9525" marB="0" anchor="ctr"/>
                </a:tc>
              </a:tr>
              <a:tr h="370840">
                <a:tc v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Reverse</a:t>
                      </a:r>
                      <a:endParaRPr lang="ko-KR" altLang="en-US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222222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CATCAGGCCCTGCAACACTA</a:t>
                      </a:r>
                    </a:p>
                  </a:txBody>
                  <a:tcPr marL="9525" marR="9525" marT="9525" marB="0" anchor="ctr"/>
                </a:tc>
              </a:tr>
              <a:tr h="370840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Bmpr1</a:t>
                      </a:r>
                      <a:r>
                        <a:rPr lang="el-GR" altLang="ko-KR" dirty="0" smtClean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α</a:t>
                      </a:r>
                      <a:endParaRPr lang="ko-KR" altLang="en-US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Forward</a:t>
                      </a:r>
                      <a:endParaRPr lang="ko-KR" altLang="en-US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TGTGTGTGTGAAACGCTTGC</a:t>
                      </a:r>
                    </a:p>
                  </a:txBody>
                  <a:tcPr marL="9525" marR="9525" marT="9525" marB="0" anchor="ctr"/>
                </a:tc>
              </a:tr>
              <a:tr h="370840">
                <a:tc v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Reverse</a:t>
                      </a:r>
                      <a:endParaRPr lang="ko-KR" altLang="en-US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AGTACCCAGAGGTTGACCAG</a:t>
                      </a:r>
                    </a:p>
                  </a:txBody>
                  <a:tcPr marL="9525" marR="9525" marT="9525" marB="0" anchor="ctr"/>
                </a:tc>
              </a:tr>
              <a:tr h="0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Bmpr1</a:t>
                      </a:r>
                      <a:r>
                        <a:rPr lang="el-GR" altLang="ko-KR" dirty="0" smtClean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β</a:t>
                      </a:r>
                      <a:endParaRPr lang="ko-KR" altLang="en-US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Forward</a:t>
                      </a:r>
                      <a:endParaRPr lang="ko-KR" altLang="en-US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TCAACTTACTGCCCGACACA</a:t>
                      </a:r>
                    </a:p>
                  </a:txBody>
                  <a:tcPr marL="9525" marR="9525" marT="9525" marB="0" anchor="ctr"/>
                </a:tc>
              </a:tr>
              <a:tr h="319405">
                <a:tc v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Reverse</a:t>
                      </a:r>
                      <a:endParaRPr lang="ko-KR" altLang="en-US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TTGCCTGAAAGAGCTGCCTA</a:t>
                      </a:r>
                    </a:p>
                  </a:txBody>
                  <a:tcPr marL="9525" marR="9525" marT="9525" marB="0" anchor="ctr"/>
                </a:tc>
              </a:tr>
              <a:tr h="273050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Bmpr2</a:t>
                      </a:r>
                      <a:endParaRPr lang="ko-KR" altLang="en-US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Forward</a:t>
                      </a:r>
                      <a:endParaRPr lang="ko-KR" altLang="en-US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TCGATGTCCAGCACACCATT</a:t>
                      </a:r>
                    </a:p>
                  </a:txBody>
                  <a:tcPr marL="9525" marR="9525" marT="9525" marB="0" anchor="ctr"/>
                </a:tc>
              </a:tr>
              <a:tr h="226695">
                <a:tc v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Reverse</a:t>
                      </a:r>
                      <a:endParaRPr lang="ko-KR" altLang="en-US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CTGTGCAACATTTGTGGCGT</a:t>
                      </a:r>
                    </a:p>
                  </a:txBody>
                  <a:tcPr marL="9525" marR="9525" marT="9525" marB="0" anchor="ctr"/>
                </a:tc>
              </a:tr>
              <a:tr h="180340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PPAR</a:t>
                      </a:r>
                      <a:r>
                        <a:rPr lang="el-GR" altLang="ko-KR" dirty="0" smtClean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γ</a:t>
                      </a:r>
                      <a:endParaRPr lang="ko-KR" altLang="en-US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Forward</a:t>
                      </a:r>
                      <a:endParaRPr lang="ko-KR" altLang="en-US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GCTGCCTGGGGTATTGGGT</a:t>
                      </a:r>
                    </a:p>
                  </a:txBody>
                  <a:tcPr marL="9525" marR="9525" marT="9525" marB="0" anchor="ctr"/>
                </a:tc>
              </a:tr>
              <a:tr h="133985">
                <a:tc v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Reverse</a:t>
                      </a:r>
                      <a:endParaRPr lang="ko-KR" altLang="en-US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TCAGTGGTTCACCGCTTCTT</a:t>
                      </a:r>
                    </a:p>
                  </a:txBody>
                  <a:tcPr marL="9525" marR="9525" marT="9525" marB="0" anchor="ctr"/>
                </a:tc>
              </a:tr>
              <a:tr h="182880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dirty="0" err="1" smtClean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Adipsin</a:t>
                      </a:r>
                      <a:endParaRPr lang="ko-KR" altLang="en-US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Forward</a:t>
                      </a:r>
                      <a:endParaRPr lang="ko-KR" altLang="en-US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 TACATGGCTTCCGTGCAAGT</a:t>
                      </a:r>
                    </a:p>
                  </a:txBody>
                  <a:tcPr marL="9525" marR="9525" marT="9525" marB="0" anchor="ctr"/>
                </a:tc>
              </a:tr>
              <a:tr h="18288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Reverse</a:t>
                      </a:r>
                      <a:endParaRPr lang="ko-KR" altLang="en-US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 CATGGTACGTGCGCAGATTG</a:t>
                      </a:r>
                    </a:p>
                  </a:txBody>
                  <a:tcPr marL="9525" marR="9525" marT="9525" marB="0" anchor="ctr"/>
                </a:tc>
              </a:tr>
              <a:tr h="182880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C/EBP</a:t>
                      </a:r>
                      <a:r>
                        <a:rPr lang="el-GR" altLang="ko-KR" dirty="0" smtClean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α</a:t>
                      </a:r>
                      <a:endParaRPr lang="ko-KR" altLang="en-US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Forward</a:t>
                      </a:r>
                      <a:endParaRPr lang="ko-KR" altLang="en-US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TCGGTGGACAAGAACAGCAA</a:t>
                      </a:r>
                    </a:p>
                  </a:txBody>
                  <a:tcPr marL="9525" marR="9525" marT="9525" marB="0" anchor="ctr"/>
                </a:tc>
              </a:tr>
              <a:tr h="18288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Reverse</a:t>
                      </a:r>
                      <a:endParaRPr lang="ko-KR" altLang="en-US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TTCATTTTTCTCACGGGGCCA</a:t>
                      </a: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020620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2</TotalTime>
  <Words>58</Words>
  <Application>Microsoft Office PowerPoint</Application>
  <PresentationFormat>와이드스크린</PresentationFormat>
  <Paragraphs>43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Arial Unicode MS</vt:lpstr>
      <vt:lpstr>맑은 고딕</vt:lpstr>
      <vt:lpstr>Arial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3</cp:revision>
  <dcterms:created xsi:type="dcterms:W3CDTF">2017-09-26T08:37:00Z</dcterms:created>
  <dcterms:modified xsi:type="dcterms:W3CDTF">2017-10-10T05:20:46Z</dcterms:modified>
</cp:coreProperties>
</file>